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06" autoAdjust="0"/>
    <p:restoredTop sz="94660"/>
  </p:normalViewPr>
  <p:slideViewPr>
    <p:cSldViewPr snapToGrid="0">
      <p:cViewPr varScale="1">
        <p:scale>
          <a:sx n="132" d="100"/>
          <a:sy n="132" d="100"/>
        </p:scale>
        <p:origin x="150" y="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A81B7F-7A58-4BAB-800B-B02A130892B9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4399DF-7AF6-4D84-A27A-5B257827D3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1952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en-CA" sz="1800" b="0" i="0" u="none" strike="noStrike" baseline="0" dirty="0">
              <a:solidFill>
                <a:srgbClr val="231F20"/>
              </a:solidFill>
              <a:latin typeface="FranklinGothic-BookCnd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8C3E2E-D309-4BA9-A5C2-11F94130536B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84136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1874D-319E-4570-BE66-AA3FD59CC6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4D39E2-B381-4378-8781-8E36E8074B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AA7856-114E-4CBE-BEA1-9CC92425A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A2D983-8E5C-4074-89BC-A7DDF0B48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E2B59F-8A94-4329-882B-989DA093B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833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5F4D07-D484-4B5A-BF96-EB1577FE35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250CEF-5913-4203-8565-D3562A2538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D54E1A-4050-4AED-84BB-E2CB431B2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DD4B83-B745-42BD-8242-0A4346743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22F79F-2401-42DF-9BF4-69294CF717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584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0C92F1C-4B9A-495D-BB4F-975E6AF987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0BAD7C-7B6C-473D-999A-D36704CD1B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F4CF8B-704E-4D6B-886A-D5CDA6A11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A400F2-442E-4A10-AA64-42DD20007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8C5751-1532-487E-8381-B56A544A8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449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74C272-9CFF-482A-BBD4-67C279558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DFBCBE-5005-496F-B269-B4B6D10E64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5A386D-F8A2-435C-9DEB-07E8E7D3B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2E2CBD-505D-450E-A00A-C536653D9F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32DCEB-7949-42AA-AF96-E932CDF66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420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E6B6C9-E43C-4B7C-BFAA-B6E6D9721E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DA135D-DC1E-44C8-A20A-ECE7CE6D67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DF8170-0DAD-4DA3-A177-2C6537855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AB4166-90E3-44D7-9938-44735A8EC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256B1B-3403-4CDF-9F81-DB6F76682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705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737D0A-CA83-48B5-BC57-24E0E574E5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FBFC23-F014-4C74-A918-1A37EAD11F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2C0F04-6179-4C12-94CD-6DF15A4590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36A4E0-117B-47C6-9FE4-9B549F09D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F306BA-67FE-4B57-96B2-A1F95CDE1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4E8032-E9A3-40C3-9C22-38597365E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417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81D20-DDB6-45D8-BD15-0495050458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9B28A8-6DFE-44C1-B830-E99AB7E554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88CF7D-124B-42C3-8185-326489EC84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0B3BC9-051B-408B-B289-BBA849A64C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9481C88-982A-4847-A39A-9CC3897638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E5497A-CA8D-4160-9A6C-7AF2D90CA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21767B-4718-4722-8821-E775A0EEE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8B6BB6-1ED4-4FCA-BB75-8650684E4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46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2961B8-9633-48DE-9C4A-A08FA75BD2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6DB85C-D7F7-4CC6-996D-25FF1CEFE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DF21B63-0DFF-485F-91DD-5B12B5C7C7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1ACA2A-C56D-49D1-9545-AB50186583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869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9D2822-331D-4AA8-8570-28770E446B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829137-A28C-46A2-A8BB-739A5456F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7E820D-22F2-43B1-9D91-8E0776358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648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998D7-A8D4-421F-BD17-D580D9690D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300925-A521-487A-AC10-2F9D26A4C3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07A16E-9DBF-4160-9A88-DF4D86FF93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01F534-CBA4-4E0D-8C5E-541A6E675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82DC76-F727-4F8E-A52C-2ED40C202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A50FA2-61CA-4828-802F-19F4E1E002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471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D9910-B0A8-458A-843F-B5D9F57D9E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BE1168-7D77-46AC-A52B-DE05DA62E7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271A5F-28DB-4EFA-B841-1AC22DF1F7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A2FFEC-0B3B-43BB-A987-6AE1697642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391488-68A5-4C86-9FEA-E5F6F676F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5F5E88-3DA0-433F-9B3E-313FAB2C5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185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0CEF20D-35CC-4E5A-A97F-7D0E90237D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8ED104-64C9-4F63-B152-B790A191B0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C94A-B09E-47EA-8C43-A8C5F80034A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0398C4-FFB3-4B5E-80CC-59076F040707}" type="datetimeFigureOut">
              <a:rPr lang="en-US" smtClean="0"/>
              <a:t>2022/03/0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46345B-782F-417A-B262-79D266285A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87593F-C8AD-48B3-ADF0-DDDCB8ACAC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7EA76A-6E59-4EE8-9F47-3865A31C88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109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55CC129-8FAE-4E97-97F3-FC4008FC6CBF}"/>
              </a:ext>
            </a:extLst>
          </p:cNvPr>
          <p:cNvSpPr txBox="1"/>
          <p:nvPr/>
        </p:nvSpPr>
        <p:spPr>
          <a:xfrm>
            <a:off x="859050" y="2188111"/>
            <a:ext cx="81070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0" i="0" u="none" strike="noStrike" baseline="0" dirty="0">
                <a:solidFill>
                  <a:srgbClr val="131413"/>
                </a:solidFill>
                <a:latin typeface="ShhprnAdvTT3713a231"/>
              </a:rPr>
              <a:t>Multiple regression analysis of </a:t>
            </a:r>
            <a:r>
              <a:rPr lang="en-US" sz="1800" b="0" i="0" u="none" strike="noStrike" baseline="0" dirty="0" err="1">
                <a:solidFill>
                  <a:srgbClr val="131413"/>
                </a:solidFill>
                <a:latin typeface="ShhprnAdvTT3713a231"/>
              </a:rPr>
              <a:t>lncRNAs</a:t>
            </a:r>
            <a:r>
              <a:rPr lang="en-US" sz="1800" b="0" i="0" u="none" strike="noStrike" baseline="0" dirty="0">
                <a:solidFill>
                  <a:srgbClr val="131413"/>
                </a:solidFill>
                <a:latin typeface="ShhprnAdvTT3713a231"/>
              </a:rPr>
              <a:t> to predict DR stage </a:t>
            </a:r>
            <a:endParaRPr lang="en-CA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F7AC91-8F7A-AF4B-97A9-D214DC6C4F0D}"/>
              </a:ext>
            </a:extLst>
          </p:cNvPr>
          <p:cNvSpPr txBox="1"/>
          <p:nvPr/>
        </p:nvSpPr>
        <p:spPr>
          <a:xfrm>
            <a:off x="-18765" y="-7487"/>
            <a:ext cx="23116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>
                <a:solidFill>
                  <a:srgbClr val="131413"/>
                </a:solidFill>
                <a:latin typeface="KrgshrAdvTT577c760c"/>
              </a:rPr>
              <a:t>Supplementary table 1</a:t>
            </a:r>
            <a:endParaRPr lang="en-US" b="1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440839E-3728-477A-B95E-DB7573D4319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28284" y="2867958"/>
          <a:ext cx="10441288" cy="2238114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252566">
                  <a:extLst>
                    <a:ext uri="{9D8B030D-6E8A-4147-A177-3AD203B41FA5}">
                      <a16:colId xmlns:a16="http://schemas.microsoft.com/office/drawing/2014/main" val="182349814"/>
                    </a:ext>
                  </a:extLst>
                </a:gridCol>
                <a:gridCol w="705642">
                  <a:extLst>
                    <a:ext uri="{9D8B030D-6E8A-4147-A177-3AD203B41FA5}">
                      <a16:colId xmlns:a16="http://schemas.microsoft.com/office/drawing/2014/main" val="2167028045"/>
                    </a:ext>
                  </a:extLst>
                </a:gridCol>
                <a:gridCol w="1047436">
                  <a:extLst>
                    <a:ext uri="{9D8B030D-6E8A-4147-A177-3AD203B41FA5}">
                      <a16:colId xmlns:a16="http://schemas.microsoft.com/office/drawing/2014/main" val="2976853794"/>
                    </a:ext>
                  </a:extLst>
                </a:gridCol>
                <a:gridCol w="5435644">
                  <a:extLst>
                    <a:ext uri="{9D8B030D-6E8A-4147-A177-3AD203B41FA5}">
                      <a16:colId xmlns:a16="http://schemas.microsoft.com/office/drawing/2014/main" val="67931395"/>
                    </a:ext>
                  </a:extLst>
                </a:gridCol>
              </a:tblGrid>
              <a:tr h="444065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enotype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CA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ple Regression Statistics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97361870"/>
                  </a:ext>
                </a:extLst>
              </a:tr>
              <a:tr h="444065">
                <a:tc>
                  <a:txBody>
                    <a:bodyPr/>
                    <a:lstStyle/>
                    <a:p>
                      <a:pPr algn="ctr" fontAlgn="ctr"/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CA" sz="1200" u="none" strike="noStrike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 F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s</a:t>
                      </a:r>
                      <a:endParaRPr lang="en-CA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541356056"/>
                  </a:ext>
                </a:extLst>
              </a:tr>
              <a:tr h="444065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ril+/Hotair+/HULC+/(H19)</a:t>
                      </a:r>
                      <a:endParaRPr lang="en-CA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RIL (0.78), HOTAIR (0.43), HULC (0.10)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095101638"/>
                  </a:ext>
                </a:extLst>
              </a:tr>
              <a:tr h="444065"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IAT)/Wisper+/ZFAS1+/(H19)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SPER (0.11), ZFAS1 (0.43)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143060"/>
                  </a:ext>
                </a:extLst>
              </a:tr>
              <a:tr h="461854"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RIL+/Hotair+/HULC+/Wisper+/ZFAS1+/(H19)</a:t>
                      </a:r>
                      <a:endParaRPr lang="pt-BR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RIL (0.52), HOTAIR (0.43), HULC (0.11), WISPER (0.28), ZFAS1 (0.50)</a:t>
                      </a:r>
                      <a:endParaRPr lang="en-CA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675307708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22254A26-310A-4B85-91D8-1AAD54ADE29D}"/>
              </a:ext>
            </a:extLst>
          </p:cNvPr>
          <p:cNvSpPr txBox="1"/>
          <p:nvPr/>
        </p:nvSpPr>
        <p:spPr>
          <a:xfrm>
            <a:off x="728283" y="5226090"/>
            <a:ext cx="108595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0" i="0" u="none" strike="noStrike" baseline="0" dirty="0">
                <a:solidFill>
                  <a:srgbClr val="131413"/>
                </a:solidFill>
                <a:latin typeface="KrgshrAdvTT577c760c"/>
              </a:rPr>
              <a:t>Note: The statistics was performed in Excel. </a:t>
            </a:r>
            <a:r>
              <a:rPr lang="en-US" dirty="0">
                <a:solidFill>
                  <a:srgbClr val="131413"/>
                </a:solidFill>
                <a:latin typeface="KrgshrAdvTT577c760c"/>
              </a:rPr>
              <a:t>Significance F was calculated using ANOVA. Alpha was considered 0.05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776843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Office PowerPoint</Application>
  <PresentationFormat>Widescreen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FranklinGothic-BookCnd</vt:lpstr>
      <vt:lpstr>KrgshrAdvTT577c760c</vt:lpstr>
      <vt:lpstr>ShhprnAdvTT3713a231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brata Chakrabarti</dc:creator>
  <cp:lastModifiedBy>Subrata Chakrabarti</cp:lastModifiedBy>
  <cp:revision>1</cp:revision>
  <dcterms:created xsi:type="dcterms:W3CDTF">2022-03-02T17:01:43Z</dcterms:created>
  <dcterms:modified xsi:type="dcterms:W3CDTF">2022-03-02T17:02:09Z</dcterms:modified>
</cp:coreProperties>
</file>